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1293B0-6106-42F1-8A3C-8EF596126B5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D6006C-A75F-4AFC-84CB-C357E375EAC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395D03-A964-44BE-A13D-6A18F3A54FD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CEAF95-5578-4B4D-A703-4FBD3936114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86F358-4639-4FD1-B98A-15B760A5CA8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9B5D1B-4FF3-4AD9-A26C-28565236727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89E0F2-2A41-4F64-8891-9781F67185C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E4FADF-BFF0-42E0-85AD-ABA0A345882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6B49F4-0793-4BF5-BCAD-8E919882E45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615009-00AF-45C9-97DF-E2D7D5F4407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E579F7-CA3E-402A-B692-645B19B2E5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427846-86E7-4FD3-A3FC-EB97051A5BD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l-G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l-G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l-G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A9F9D7F-0A72-4ACD-AE93-5835482B06CE}" type="slidenum">
              <a:rPr b="0" lang="el-G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2117880" y="1938240"/>
          <a:ext cx="2606400" cy="2710080"/>
        </p:xfrm>
        <a:graphic>
          <a:graphicData uri="http://schemas.openxmlformats.org/drawingml/2006/table">
            <a:tbl>
              <a:tblPr/>
              <a:tblGrid>
                <a:gridCol w="936000"/>
                <a:gridCol w="605160"/>
                <a:gridCol w="661680"/>
                <a:gridCol w="403560"/>
              </a:tblGrid>
              <a:tr h="27144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ampl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ler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egFac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I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964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17A_U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Yello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.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144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17A_WOU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Yello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4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.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18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17A_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Yello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2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.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144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17B_U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Yello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964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17B_WOU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e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0.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18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17B_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rang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8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.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144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57B_U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Yello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964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57B_WOU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rang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6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18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57B_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Yello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03-21T22:54:06Z</dcterms:created>
  <dc:creator>KUBED</dc:creator>
  <dc:description/>
  <dc:language>en-US</dc:language>
  <cp:lastModifiedBy>D. Marie Kube</cp:lastModifiedBy>
  <dcterms:modified xsi:type="dcterms:W3CDTF">2007-03-14T15:17:12Z</dcterms:modified>
  <cp:revision>7</cp:revision>
  <dc:subject/>
  <dc:title>Slide 1</dc:title>
</cp:coreProperties>
</file>